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5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451058" y="972222"/>
            <a:ext cx="11084574" cy="3983942"/>
            <a:chOff x="451058" y="972222"/>
            <a:chExt cx="11084574" cy="3983942"/>
          </a:xfrm>
        </p:grpSpPr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4458" y="972222"/>
              <a:ext cx="5381289" cy="3429000"/>
            </a:xfrm>
            <a:prstGeom prst="rect">
              <a:avLst/>
            </a:prstGeom>
          </p:spPr>
        </p:pic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15746" y="1003044"/>
              <a:ext cx="5219885" cy="3438525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707737" y="4360126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38560" y="4648387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직선 연결선 26"/>
            <p:cNvCxnSpPr/>
            <p:nvPr/>
          </p:nvCxnSpPr>
          <p:spPr>
            <a:xfrm>
              <a:off x="1558367" y="4669407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2751291" y="4669407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>
            <a:xfrm>
              <a:off x="3979347" y="4669407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5172271" y="4669407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/>
            <p:cNvCxnSpPr/>
            <p:nvPr/>
          </p:nvCxnSpPr>
          <p:spPr>
            <a:xfrm>
              <a:off x="6405818" y="4669407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33"/>
            <p:cNvCxnSpPr/>
            <p:nvPr/>
          </p:nvCxnSpPr>
          <p:spPr>
            <a:xfrm>
              <a:off x="7439433" y="4670438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>
            <a:xfrm>
              <a:off x="8453106" y="4671468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9465700" y="4669407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>
              <a:off x="10488568" y="4669407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 rot="16200000">
              <a:off x="-102147" y="2505292"/>
              <a:ext cx="14449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PM</a:t>
              </a:r>
              <a:r>
                <a:rPr lang="en-US" altLang="ko-KR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, µg/m</a:t>
              </a:r>
              <a:r>
                <a:rPr lang="en-US" altLang="ko-KR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0026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6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5:29Z</dcterms:modified>
</cp:coreProperties>
</file>